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8" r:id="rId12"/>
    <p:sldId id="270" r:id="rId13"/>
    <p:sldId id="269" r:id="rId14"/>
    <p:sldId id="266" r:id="rId15"/>
    <p:sldId id="267" r:id="rId16"/>
    <p:sldId id="271" r:id="rId17"/>
    <p:sldId id="272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6" autoAdjust="0"/>
    <p:restoredTop sz="94660"/>
  </p:normalViewPr>
  <p:slideViewPr>
    <p:cSldViewPr snapToGrid="0">
      <p:cViewPr varScale="1">
        <p:scale>
          <a:sx n="87" d="100"/>
          <a:sy n="87" d="100"/>
        </p:scale>
        <p:origin x="80" y="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B1D7DE-7513-DBA2-1BE8-4EEDB3B090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A05924B-C481-67D0-B2BD-8EBB61296E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E69EBC-1910-8A70-0D3C-6FFB771B2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D69E77-C7F9-C8E4-D97B-143DDB2B1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0C3314-8D42-C56D-D756-158C6955B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280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26A394-BE55-6CA4-FE5E-54DD060496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7DB50F-7B28-4EF8-EC53-1D45C105EF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B594C6-1FA8-22B0-3370-B79F45F6E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CFD9EC-94DB-47A0-EC3B-74EB94F0E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D81E12-1B18-AD28-3758-891221E1C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750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306DC2-5A7F-5A31-89B2-417ED8CACC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0D2F3B-4353-1AA8-AE97-57309559E3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FDC60A-779A-09B9-A40F-90651144B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B2F941-50F8-7212-99D2-7125C2DEB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EB2FF4-3971-C320-6F22-1BCB1B52D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159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10DB0B-6A5F-98DA-99A4-57C1CD760B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FF77EF-8B9D-1117-FCD7-E9030461FC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C3F475-7C28-ED12-D0DA-54E045ED4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0C2856-BA73-6704-6B68-F45B86BB61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02DD40-AB35-8E2F-C8CD-33F57E721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90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5B22E8-9E79-A2D1-E3FA-9A527811B8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342BFD-56C0-84DE-2811-1BAAB55ED4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BB09B6-19B2-C803-B8B0-943C56356E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B96538-2EFF-D6AC-BF79-B00EB8AA4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92C285-3F7D-F158-166C-FBFB6CC3C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968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59BC1A-0AE9-F670-8A6A-0BD4E67653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2CEE14-2E9F-87BA-9262-F323A51332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8469C6-B472-24B8-36B1-F415E7FA6E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8CD80F-A594-30BF-BA9E-8ABE822CD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41FC05-C5BB-628B-FBF4-AD7DA6FC3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031BAD-5687-F2E6-B597-0AB59DF50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126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22743E-DD7C-F391-39EE-5FE1C3B8DD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D285A8-BC5D-461D-DC0C-D07390C43E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2878E6-4F0D-01C2-ABA3-331EFD16C8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249CAE-6528-E5A0-1391-0AB419EA26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C11CFDA-4D0C-8575-F7C4-326731AB984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A64757B-D9CF-01B8-1904-C452464A7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E19809F-B4DE-64FA-5115-430B74CC3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59C049C-6802-B6E4-A752-08420B6B3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68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48EC92-8538-A2BC-7196-2E1936E135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51F393-EBCD-6800-54FF-7FDB51FCD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A68C1E7-D602-496B-5942-4BA423208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9EA414-8B8D-51E3-D2E7-7F40F29F66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921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1E6E3AF-7E3C-E84F-04DE-717803547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B3C078-A101-91DF-05F4-3A50C6B56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152503F-E246-771A-8C83-A5FF33856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472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B48577-1FBE-A62D-BD70-27DDA2CA7E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A5FA6D-D958-E16E-0F55-5FB242F491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CF845D-231C-E496-ECD4-C70F9BD03A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89D8EA-B15E-AB57-9CD3-B737CD390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605730-8A06-52C9-52B1-59C44A076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611AD6-2444-F657-B062-BC52D951C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934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65EE8B-815B-ED23-D88C-E5BC914BB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72872F-CB44-3C0A-6C06-A8FDCD5F569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EA82CD-803E-8A5C-19C9-D72217ED6C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1D449B-13C6-2BDE-6247-FD4C181E8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D81FBF-2B57-FD52-2DAE-1E078C9ABE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CBA4DB-593E-68EB-777B-4D30312E0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225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ACE282-261B-EB96-1CC8-E04B6C5451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8D25DF-33E9-1A42-2800-FD06C9B1E4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A00144-A0B4-25AF-1B53-A1DB1BD9E1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05DEEE-78DD-45D6-8E06-7A942B642C31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97A46A-AC94-260F-F017-E6009F4130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6B351C-A124-D7FC-0AA5-29C4701340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D46222D-4CE9-4D76-8F6C-FA14319EB5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024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gi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gi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gi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gi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gi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gi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gi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g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g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gi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gi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g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CF5A2A-D182-B83C-52DA-B7454E26910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sz="6000" b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Time-Domain Visualization of Electron-Phonon Coupling in Nanographenes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98B920-C51B-9288-0F63-A9A9A3A72B3E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Rafael Muñoz-Mármol,</a:t>
            </a:r>
            <a:r>
              <a:rPr lang="en-US" sz="1800" i="1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†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 Saurav Raj,</a:t>
            </a:r>
            <a:r>
              <a:rPr lang="en-US" sz="1800" i="1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†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 Mattia Russo,</a:t>
            </a:r>
            <a:r>
              <a:rPr lang="en-US" sz="1800" i="1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†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 Gianluca Serra,</a:t>
            </a:r>
            <a:r>
              <a:rPr lang="en-US" sz="1800" i="1" baseline="30000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†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 Hao Zhao, Giacomo Bassi, Andrea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Lucotti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, Francesco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Scotognella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, Giulio Cerullo, Guglielmo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Lanzani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, Matteo Tommasini,* Margherita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Maiuri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,* Akimitsu Narita,* Giuseppe Maria </a:t>
            </a:r>
            <a:r>
              <a:rPr lang="en-US" sz="1800" i="1" dirty="0" err="1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Paternò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*</a:t>
            </a:r>
            <a:endParaRPr lang="en-GB" sz="1800" dirty="0">
              <a:effectLst/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754610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9586681-AF4F-56EC-C827-68B47049D82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4EC621-B0B0-54D1-8D8E-B2E02F2E27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D0AD85FF-FDA4-B7C6-6289-8CD54E0A47E7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63457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Breathing Mode – 322 cm</a:t>
            </a:r>
            <a:r>
              <a:rPr lang="en-US" sz="3600" baseline="30000" dirty="0"/>
              <a:t>-1</a:t>
            </a:r>
          </a:p>
        </p:txBody>
      </p:sp>
      <p:pic>
        <p:nvPicPr>
          <p:cNvPr id="3" name="Immagine 6">
            <a:extLst>
              <a:ext uri="{FF2B5EF4-FFF2-40B4-BE49-F238E27FC236}">
                <a16:creationId xmlns:a16="http://schemas.microsoft.com/office/drawing/2014/main" id="{9265283F-81F3-BD24-D54C-C1ADD1B7F1B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3724355" y="1697369"/>
            <a:ext cx="4747241" cy="2941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102889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A5AE18C-1545-26D8-96DF-CC36B5F4214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7CCC1B-2C12-F8F5-92A5-2474CFB75C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AFD748E2-8576-AD40-C1A3-50F5A74C544A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63457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Breathing Mode – 347 cm</a:t>
            </a:r>
            <a:r>
              <a:rPr lang="en-US" sz="3600" baseline="30000" dirty="0"/>
              <a:t>-1</a:t>
            </a:r>
          </a:p>
        </p:txBody>
      </p:sp>
      <p:pic>
        <p:nvPicPr>
          <p:cNvPr id="3" name="Immagine 6">
            <a:extLst>
              <a:ext uri="{FF2B5EF4-FFF2-40B4-BE49-F238E27FC236}">
                <a16:creationId xmlns:a16="http://schemas.microsoft.com/office/drawing/2014/main" id="{063890ED-5075-620F-F21F-18309E1D120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3724355" y="1697369"/>
            <a:ext cx="4747241" cy="2941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566993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0961D8-EF69-416C-D635-AB61C0E06D7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DED8A8-3CFD-3D28-A032-3DF4EF6EEB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FE970067-858A-881F-E601-AF3378AAF23D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63457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Breathing Mode – 398 cm</a:t>
            </a:r>
            <a:r>
              <a:rPr lang="en-US" sz="3600" baseline="30000" dirty="0"/>
              <a:t>-1</a:t>
            </a:r>
          </a:p>
        </p:txBody>
      </p:sp>
      <p:pic>
        <p:nvPicPr>
          <p:cNvPr id="3" name="Immagine 2" descr="Immagine che contiene modello, favo&#10;&#10;Descrizione generata automaticamente">
            <a:extLst>
              <a:ext uri="{FF2B5EF4-FFF2-40B4-BE49-F238E27FC236}">
                <a16:creationId xmlns:a16="http://schemas.microsoft.com/office/drawing/2014/main" id="{9B04C73A-B985-B649-B56A-FB36E41F84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4296000" y="18218"/>
            <a:ext cx="3600000" cy="6821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745130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60A0BD6-9A1B-64FA-B93A-4173285F4E2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9AB4CB-1CE8-1AC7-E247-6F15A92AB8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976E0929-6F05-E53B-4D1E-CCF01E6B3D04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63457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Breathing Mode – 399 cm</a:t>
            </a:r>
            <a:r>
              <a:rPr lang="en-US" sz="3600" baseline="30000" dirty="0"/>
              <a:t>-1</a:t>
            </a:r>
          </a:p>
        </p:txBody>
      </p:sp>
      <p:pic>
        <p:nvPicPr>
          <p:cNvPr id="4" name="Immagine 2" descr="Immagine che contiene modello, favo, arte&#10;&#10;Descrizione generata automaticamente">
            <a:extLst>
              <a:ext uri="{FF2B5EF4-FFF2-40B4-BE49-F238E27FC236}">
                <a16:creationId xmlns:a16="http://schemas.microsoft.com/office/drawing/2014/main" id="{7B85868D-81CB-5945-B6D7-55FFAD2B30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4296000" y="18218"/>
            <a:ext cx="3600000" cy="6821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520515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1EE3BA0-26D0-ECCF-3283-A29389FC952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A71032-C6B7-72A2-5F8C-3EFA53DB77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CC6D10D6-6B6F-67E7-4CAB-431A99C6EA0E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63457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D-Mode – 1245 cm</a:t>
            </a:r>
            <a:r>
              <a:rPr lang="en-US" sz="3600" baseline="30000" dirty="0"/>
              <a:t>-1</a:t>
            </a:r>
          </a:p>
        </p:txBody>
      </p:sp>
      <p:pic>
        <p:nvPicPr>
          <p:cNvPr id="3" name="Immagine 6">
            <a:extLst>
              <a:ext uri="{FF2B5EF4-FFF2-40B4-BE49-F238E27FC236}">
                <a16:creationId xmlns:a16="http://schemas.microsoft.com/office/drawing/2014/main" id="{56711390-3344-F3C7-6D43-A726385657D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3190521" y="1629000"/>
            <a:ext cx="5810958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512872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73D810-C7C1-3F22-9F2D-89AA6224EE2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24ABC-CC09-A36E-1777-712CDA060C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35615D32-B982-C57B-6142-D9BB02854629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63457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D-Mode – 1340 cm</a:t>
            </a:r>
            <a:r>
              <a:rPr lang="en-US" sz="3600" baseline="30000" dirty="0"/>
              <a:t>-1</a:t>
            </a:r>
          </a:p>
        </p:txBody>
      </p:sp>
      <p:pic>
        <p:nvPicPr>
          <p:cNvPr id="3" name="Immagine 6">
            <a:extLst>
              <a:ext uri="{FF2B5EF4-FFF2-40B4-BE49-F238E27FC236}">
                <a16:creationId xmlns:a16="http://schemas.microsoft.com/office/drawing/2014/main" id="{FDA87CC0-5068-3D05-933C-B78F82B7349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3190521" y="1629000"/>
            <a:ext cx="5810958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949524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39776EC-DF89-8E31-9064-EC072070417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8052E5-1AEC-53BB-2BCB-3724DCA195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DDF9F633-469C-E6B0-AF54-FC9BCE9BB4D9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63457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D-Mode – 1354 cm</a:t>
            </a:r>
            <a:r>
              <a:rPr lang="en-US" sz="3600" baseline="30000" dirty="0"/>
              <a:t>-1</a:t>
            </a:r>
          </a:p>
        </p:txBody>
      </p:sp>
      <p:pic>
        <p:nvPicPr>
          <p:cNvPr id="3" name="Immagine 2" descr="Immagine che contiene modello, favo, arte&#10;&#10;Descrizione generata automaticamente">
            <a:extLst>
              <a:ext uri="{FF2B5EF4-FFF2-40B4-BE49-F238E27FC236}">
                <a16:creationId xmlns:a16="http://schemas.microsoft.com/office/drawing/2014/main" id="{12F624A7-7E6F-F94D-AEE4-A31AE12DFE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4295999" y="18218"/>
            <a:ext cx="3600000" cy="6821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827781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4439E81-19B4-7EF9-47B5-39E41ED9C0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94F222-759B-6703-25D9-9F6408977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115DAA49-3133-E461-5330-FACE42030AF7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63457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G-Mode – 1597 cm</a:t>
            </a:r>
            <a:r>
              <a:rPr lang="en-US" sz="3600" baseline="30000" dirty="0"/>
              <a:t>-1</a:t>
            </a:r>
          </a:p>
        </p:txBody>
      </p:sp>
      <p:pic>
        <p:nvPicPr>
          <p:cNvPr id="4" name="Immagine 2" descr="Immagine che contiene modello, favo, arte&#10;&#10;Descrizione generata automaticamente">
            <a:extLst>
              <a:ext uri="{FF2B5EF4-FFF2-40B4-BE49-F238E27FC236}">
                <a16:creationId xmlns:a16="http://schemas.microsoft.com/office/drawing/2014/main" id="{9B46EB06-E0B0-7B4A-91BF-79AC89675C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4295999" y="18218"/>
            <a:ext cx="3600000" cy="6821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09044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63F17-3D17-351E-DC4F-919C5A8E60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Cl-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BB09926F-879F-244B-1543-702560991B0C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30782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Mes-Mes Mode – 130 cm</a:t>
            </a:r>
            <a:r>
              <a:rPr lang="en-US" sz="3600" baseline="30000" dirty="0"/>
              <a:t>-1</a:t>
            </a: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33B11162-706D-9A0B-9B8A-2E486E3079D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3190520" y="1629000"/>
            <a:ext cx="5810960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98556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4CE9959-C575-6918-F86F-6CF36AEFC21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84B79-797B-9DB7-EB8A-B573AFD7A8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Cl-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3347FBAD-5FD0-FC44-3432-84B7A899DD68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30782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Cl-Cl Mode – 227 cm</a:t>
            </a:r>
            <a:r>
              <a:rPr lang="en-US" sz="3600" baseline="30000" dirty="0"/>
              <a:t>-1</a:t>
            </a:r>
          </a:p>
        </p:txBody>
      </p:sp>
      <p:pic>
        <p:nvPicPr>
          <p:cNvPr id="3" name="Immagine 4" descr="Immagine che contiene favo, arte&#10;&#10;Descrizione generata automaticamente con attendibilità media">
            <a:extLst>
              <a:ext uri="{FF2B5EF4-FFF2-40B4-BE49-F238E27FC236}">
                <a16:creationId xmlns:a16="http://schemas.microsoft.com/office/drawing/2014/main" id="{AA37E167-5A15-1641-B284-667E5EE949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4295999" y="18218"/>
            <a:ext cx="3600000" cy="6821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50712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22ABE12-3F7C-8408-99F3-9058D9BC283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B45FD3-A79D-1BB2-09A3-2DECE16AA5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Cl-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29450A05-C898-BBCE-8B2C-3CD154951B13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30782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Breathing Mode – 344 cm</a:t>
            </a:r>
            <a:r>
              <a:rPr lang="en-US" sz="3600" baseline="30000" dirty="0"/>
              <a:t>-1</a:t>
            </a:r>
          </a:p>
        </p:txBody>
      </p:sp>
      <p:pic>
        <p:nvPicPr>
          <p:cNvPr id="4" name="Immagine 6">
            <a:extLst>
              <a:ext uri="{FF2B5EF4-FFF2-40B4-BE49-F238E27FC236}">
                <a16:creationId xmlns:a16="http://schemas.microsoft.com/office/drawing/2014/main" id="{06341B26-2BB0-4314-312F-4B8C378A9D5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3190519" y="1628999"/>
            <a:ext cx="5810960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39003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F01AF5D-183B-A866-945F-BB56F601C9A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2B0467-81A2-2B8B-F821-BD0D9636BF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Cl-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EBFA527C-15B9-D402-4AA1-2B0BFA83A00C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30782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D-Mode – 1234 cm</a:t>
            </a:r>
            <a:r>
              <a:rPr lang="en-US" sz="3600" baseline="30000" dirty="0"/>
              <a:t>-1</a:t>
            </a:r>
          </a:p>
        </p:txBody>
      </p:sp>
      <p:pic>
        <p:nvPicPr>
          <p:cNvPr id="3" name="Immagine 6">
            <a:extLst>
              <a:ext uri="{FF2B5EF4-FFF2-40B4-BE49-F238E27FC236}">
                <a16:creationId xmlns:a16="http://schemas.microsoft.com/office/drawing/2014/main" id="{C1669B58-EC1C-EA4A-A6A4-B6F7D3D8E2B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3190520" y="1629000"/>
            <a:ext cx="5810960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79688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82C1578-66B0-D213-655F-B5548528BC0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3F950-5446-570D-96D1-03A56E716E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Cl-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990BA716-74FB-F858-56C1-4FF9981BB21C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30782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D-Mode – 1339 cm</a:t>
            </a:r>
            <a:r>
              <a:rPr lang="en-US" sz="3600" baseline="30000" dirty="0"/>
              <a:t>-1</a:t>
            </a:r>
          </a:p>
        </p:txBody>
      </p:sp>
      <p:pic>
        <p:nvPicPr>
          <p:cNvPr id="4" name="Immagine 6">
            <a:extLst>
              <a:ext uri="{FF2B5EF4-FFF2-40B4-BE49-F238E27FC236}">
                <a16:creationId xmlns:a16="http://schemas.microsoft.com/office/drawing/2014/main" id="{CC48C2BF-53FB-5E88-46D8-620A312DA4C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3190520" y="1629000"/>
            <a:ext cx="5810960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31093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D551802-E996-F39B-95B5-2D67F696300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D11848-D120-1D5E-0CFB-FC8839D1ED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Cl-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6695EB8B-D55A-5211-A26A-BA63DA2ED101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30782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G-Mode – 1556 cm</a:t>
            </a:r>
            <a:r>
              <a:rPr lang="en-US" sz="3600" baseline="30000" dirty="0"/>
              <a:t>-1</a:t>
            </a:r>
          </a:p>
        </p:txBody>
      </p:sp>
      <p:pic>
        <p:nvPicPr>
          <p:cNvPr id="3" name="Immagine 6">
            <a:extLst>
              <a:ext uri="{FF2B5EF4-FFF2-40B4-BE49-F238E27FC236}">
                <a16:creationId xmlns:a16="http://schemas.microsoft.com/office/drawing/2014/main" id="{9A6140EB-8E35-B4F3-5B6A-D4512E9A1EA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3683784" y="1629000"/>
            <a:ext cx="5810960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05460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401DB72-A922-837F-49FA-2EAFD1FB1B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475E1-AC9B-B397-E210-62B506D50D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5C744463-8E9D-A6E7-41B5-C4E7E8166B03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63457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Mes-Mes Mode – 133 cm</a:t>
            </a:r>
            <a:r>
              <a:rPr lang="en-US" sz="3600" baseline="30000" dirty="0"/>
              <a:t>-1</a:t>
            </a:r>
          </a:p>
        </p:txBody>
      </p:sp>
      <p:pic>
        <p:nvPicPr>
          <p:cNvPr id="4" name="Immagine 6">
            <a:extLst>
              <a:ext uri="{FF2B5EF4-FFF2-40B4-BE49-F238E27FC236}">
                <a16:creationId xmlns:a16="http://schemas.microsoft.com/office/drawing/2014/main" id="{A3D3E0C8-2D44-BB1A-3E6A-0AC25E5CF03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3190521" y="1629000"/>
            <a:ext cx="5810958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624160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D821B41-00DA-A6A1-5EA6-225F41D0178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02C18-AD46-0194-2923-38C240ED54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8648" y="78939"/>
            <a:ext cx="6260616" cy="1325563"/>
          </a:xfrm>
        </p:spPr>
        <p:txBody>
          <a:bodyPr/>
          <a:lstStyle/>
          <a:p>
            <a:r>
              <a:rPr lang="en-US" dirty="0"/>
              <a:t>DBOV-Mes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D1A16312-C46C-CCA5-4620-0188F046270A}"/>
              </a:ext>
            </a:extLst>
          </p:cNvPr>
          <p:cNvSpPr txBox="1">
            <a:spLocks/>
          </p:cNvSpPr>
          <p:nvPr/>
        </p:nvSpPr>
        <p:spPr>
          <a:xfrm>
            <a:off x="788174" y="496585"/>
            <a:ext cx="563457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3600" dirty="0"/>
              <a:t>Diagonal Mode – 273 cm</a:t>
            </a:r>
            <a:r>
              <a:rPr lang="en-US" sz="3600" baseline="30000" dirty="0"/>
              <a:t>-1</a:t>
            </a:r>
          </a:p>
        </p:txBody>
      </p:sp>
      <p:pic>
        <p:nvPicPr>
          <p:cNvPr id="3" name="Immagine 2" descr="Immagine che contiene modello, favo, arte&#10;&#10;Descrizione generata automaticamente con attendibilità media">
            <a:extLst>
              <a:ext uri="{FF2B5EF4-FFF2-40B4-BE49-F238E27FC236}">
                <a16:creationId xmlns:a16="http://schemas.microsoft.com/office/drawing/2014/main" id="{6E5AE295-ECB2-7F4E-A51D-4F7D3CB2C6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4295999" y="18218"/>
            <a:ext cx="3600000" cy="6821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3190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39</Words>
  <Application>Microsoft Office PowerPoint</Application>
  <PresentationFormat>Widescreen</PresentationFormat>
  <Paragraphs>34</Paragraphs>
  <Slides>1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2" baseType="lpstr">
      <vt:lpstr>Aptos</vt:lpstr>
      <vt:lpstr>Aptos Display</vt:lpstr>
      <vt:lpstr>Arial</vt:lpstr>
      <vt:lpstr>Times New Roman</vt:lpstr>
      <vt:lpstr>Office Theme</vt:lpstr>
      <vt:lpstr>Time-Domain Visualization of Electron-Phonon Coupling in Nanographenes</vt:lpstr>
      <vt:lpstr>Cl-DBOV-Mes</vt:lpstr>
      <vt:lpstr>Cl-DBOV-Mes</vt:lpstr>
      <vt:lpstr>Cl-DBOV-Mes</vt:lpstr>
      <vt:lpstr>Cl-DBOV-Mes</vt:lpstr>
      <vt:lpstr>Cl-DBOV-Mes</vt:lpstr>
      <vt:lpstr>Cl-DBOV-Mes</vt:lpstr>
      <vt:lpstr>DBOV-Mes</vt:lpstr>
      <vt:lpstr>DBOV-Mes</vt:lpstr>
      <vt:lpstr>DBOV-Mes</vt:lpstr>
      <vt:lpstr>DBOV-Mes</vt:lpstr>
      <vt:lpstr>DBOV-Mes</vt:lpstr>
      <vt:lpstr>DBOV-Mes</vt:lpstr>
      <vt:lpstr>DBOV-Mes</vt:lpstr>
      <vt:lpstr>DBOV-Mes</vt:lpstr>
      <vt:lpstr>DBOV-Mes</vt:lpstr>
      <vt:lpstr>DBOV-M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fael Muñoz Mármol</dc:creator>
  <cp:lastModifiedBy>Rafael Muñoz Mármol</cp:lastModifiedBy>
  <cp:revision>1</cp:revision>
  <dcterms:created xsi:type="dcterms:W3CDTF">2025-01-02T12:02:42Z</dcterms:created>
  <dcterms:modified xsi:type="dcterms:W3CDTF">2025-01-02T12:31:58Z</dcterms:modified>
</cp:coreProperties>
</file>